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7" r:id="rId2"/>
    <p:sldId id="278" r:id="rId3"/>
    <p:sldId id="279" r:id="rId4"/>
    <p:sldId id="280" r:id="rId5"/>
    <p:sldId id="281" r:id="rId6"/>
    <p:sldId id="282" r:id="rId7"/>
    <p:sldId id="283" r:id="rId8"/>
    <p:sldId id="284" r:id="rId9"/>
    <p:sldId id="285" r:id="rId10"/>
    <p:sldId id="286" r:id="rId11"/>
    <p:sldId id="287" r:id="rId12"/>
    <p:sldId id="28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97"/>
    <p:restoredTop sz="94741"/>
  </p:normalViewPr>
  <p:slideViewPr>
    <p:cSldViewPr snapToGrid="0">
      <p:cViewPr varScale="1">
        <p:scale>
          <a:sx n="103" d="100"/>
          <a:sy n="103" d="100"/>
        </p:scale>
        <p:origin x="95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11808D-7AE9-38DF-F6E3-90627B7FB0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FEF91C-0EBF-F1F6-C4C9-F7003B7F3D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67B13-CFDD-585D-A985-3BDE11B19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4AB936-CA05-68F5-F8E9-9E1F71C57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EF1C97-8036-D84D-848E-127DB1854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852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A5DC11-A834-5939-D3F1-FF688B1DB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88CB41-4CD5-71EA-3841-5B8EC9105E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E8ECAB-4374-E373-54B5-6F8E1E7E9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8C8995-357E-4F60-25E6-38973F8AA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6224C4-62EE-0BC2-5B62-8AF152032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06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5D5CFD-B539-2BB5-F7BD-E39393BA86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723189-D1B2-05AF-A1A6-159792BCBB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3989D7-8C04-6AEC-8533-518BC5363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97DCB4-8EAD-E444-5C5E-55BB7A1CB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140F00-2950-0732-304B-281A4F723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166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E8ED7-AFD8-E44B-7F95-BAE4B1798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067A46-F52B-CB27-70DD-CE4BEFAC6A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4CBB5-E0C5-1CCF-9D58-DCBABA6EE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5CDB6-EDA5-C0C8-61BA-154A2C56A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85D713-E030-7FF9-61DF-2676A5364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968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4BCAD-7F88-B3BD-E318-A0CB023CAF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DB57C8-2988-684D-FFB3-54A2D64FC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B8F6A-AB54-E43D-31B3-9EF353AED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6692CD-DDF1-3A1C-3325-58D3FDEDC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9292A-B33A-E8A1-00AD-52CB90E93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565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D0566-5A6C-3983-26DB-7ACBBBA9A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1BAE7B-0AED-60A1-B99E-5D7356CDCD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593DC7-A63F-E421-4D24-FAD033879A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CE3999-E328-8FCD-6719-EC187750C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63BA1A-1B30-B484-39B4-A45BFB90B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136AB4-F4AC-3D63-79AC-D7E6235EB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101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674D9-45F2-59BB-B361-F406E498D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429C1C-7441-BF6F-D17E-01BA7037C1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621149-1D95-7C51-D37A-46952D92AF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CB7F3D-0AF6-FEF9-7BE6-3E51E66ED1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D933EDF-0EF6-12D3-EDAB-B7F092286A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3D52D2-763C-380A-1563-842A56C3C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25EEC0-A022-831C-C61F-FCD22710E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A516749-478A-66A2-F6ED-8F33D0190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732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C98ED4-AD1E-BFCD-901B-B363B0F15A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71A104-43B2-F92F-683A-ABBF63ACB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729FA9-0A98-EDFE-FB8F-5576340E0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F2E882-3A17-24B9-C553-AF13C5650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028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C958B4-2D59-55BA-C17C-B81FDEC6A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111A1C-58E7-48C0-EB3C-C4E4B5D5C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44CD45-95DB-832A-FA5B-722FE8E70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281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20BAB1-4038-D1EB-9EBC-AD6278B61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671B9B-9619-6AC5-FDF6-DFA1AC0821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54A51-6B4C-4BEF-DFA1-E0E6288FD0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CF21C8-15EF-0EEE-6380-7064DA442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C2820-2B7D-4ED9-8B3E-AA9B69B87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95E9A5-D230-E518-FE31-14DD89210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600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3DB575-CD7C-FB0E-8522-66698F8DD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AF76FE-1461-8DBF-06B3-8443A6D9A0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4E5DD9-8E50-939F-9B8C-8FD42177B4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D2B4B0-F7D8-B6CD-755F-38B00345C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C6AF8D-22CB-A8F6-7B3D-AE38007C9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189288-E287-1508-985A-AD1B6852A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918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98ED5D-A339-3496-E5CC-FEA0A1B3D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3C3876-C934-9265-6DC1-12C8FEE17F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1C3CDD-05C2-1889-51A1-F8F806FC42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E1C4B-E021-EE49-ADD9-6B67ACF648BD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8036C8-CEFE-BE76-E0C4-92CDB786DF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A35155-35DF-C296-3D9D-A0540B4563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8644A-EA07-5A4C-8B91-B6E38013E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360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6F42E-BEDF-6988-1B0D-BF1648A30A8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kov3N1 2022.08.05 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82C3E0-B524-685F-72CB-3AE27D41311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10 days-  Normal media</a:t>
            </a:r>
          </a:p>
        </p:txBody>
      </p:sp>
    </p:spTree>
    <p:extLst>
      <p:ext uri="{BB962C8B-B14F-4D97-AF65-F5344CB8AC3E}">
        <p14:creationId xmlns:p14="http://schemas.microsoft.com/office/powerpoint/2010/main" val="23166807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90175"/>
            <a:ext cx="10515600" cy="1325563"/>
          </a:xfrm>
        </p:spPr>
        <p:txBody>
          <a:bodyPr/>
          <a:lstStyle/>
          <a:p>
            <a:r>
              <a:rPr lang="en-US" dirty="0"/>
              <a:t>GFP-N3 22.09.2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C8436E7-5107-FA32-C3BC-8991E04F1F6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856341"/>
            <a:ext cx="7772400" cy="5561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491705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80975"/>
            <a:ext cx="10515600" cy="1325563"/>
          </a:xfrm>
        </p:spPr>
        <p:txBody>
          <a:bodyPr/>
          <a:lstStyle/>
          <a:p>
            <a:r>
              <a:rPr lang="en-US" dirty="0"/>
              <a:t>Drp1(-/17)-N3-22.09.20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39ABB-1983-BD81-CF24-26FB065D35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EFB8D57-4613-8B9B-1806-4F45101E94B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1144588"/>
            <a:ext cx="7772400" cy="5440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413157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302532"/>
            <a:ext cx="10515600" cy="1325563"/>
          </a:xfrm>
        </p:spPr>
        <p:txBody>
          <a:bodyPr/>
          <a:lstStyle/>
          <a:p>
            <a:r>
              <a:rPr lang="en-US"/>
              <a:t>Drp1(16/17)-N3-22.09.20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1EDCCB5-0BB1-29FA-62FD-A809C664266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736599"/>
            <a:ext cx="7772400" cy="5384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04166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90175"/>
            <a:ext cx="10515600" cy="1325563"/>
          </a:xfrm>
        </p:spPr>
        <p:txBody>
          <a:bodyPr/>
          <a:lstStyle/>
          <a:p>
            <a:r>
              <a:rPr lang="en-US" dirty="0"/>
              <a:t>GFP-N1 22.08.0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75EFF07-1F9E-070F-10BE-8042EE36702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812799"/>
            <a:ext cx="7772400" cy="54622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5938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80975"/>
            <a:ext cx="10515600" cy="1325563"/>
          </a:xfrm>
        </p:spPr>
        <p:txBody>
          <a:bodyPr/>
          <a:lstStyle/>
          <a:p>
            <a:r>
              <a:rPr lang="en-US" dirty="0"/>
              <a:t>Drp1(-/17)-N1-22.08.0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D27C2C6-A3B6-A55A-8AAF-881A9DC9369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1030515"/>
            <a:ext cx="7772400" cy="5312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60490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302532"/>
            <a:ext cx="10515600" cy="1325563"/>
          </a:xfrm>
        </p:spPr>
        <p:txBody>
          <a:bodyPr/>
          <a:lstStyle/>
          <a:p>
            <a:r>
              <a:rPr lang="en-US" dirty="0"/>
              <a:t>Drp1(16/17)-N1-22.08.05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8E4B5264-FDFF-5F67-D70B-6E59EF4E6CF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-1" y="1252991"/>
            <a:ext cx="7532915" cy="52575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6199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6F42E-BEDF-6988-1B0D-BF1648A30A8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kov3N2 2022.08.05 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82C3E0-B524-685F-72CB-3AE27D41311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10 days-  Normal media</a:t>
            </a:r>
          </a:p>
        </p:txBody>
      </p:sp>
    </p:spTree>
    <p:extLst>
      <p:ext uri="{BB962C8B-B14F-4D97-AF65-F5344CB8AC3E}">
        <p14:creationId xmlns:p14="http://schemas.microsoft.com/office/powerpoint/2010/main" val="24726842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90175"/>
            <a:ext cx="10515600" cy="1325563"/>
          </a:xfrm>
        </p:spPr>
        <p:txBody>
          <a:bodyPr/>
          <a:lstStyle/>
          <a:p>
            <a:r>
              <a:rPr lang="en-US" dirty="0"/>
              <a:t>GFP-N2 22.08.0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8214E14-C112-5CFB-A183-DC424484FAF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921518"/>
            <a:ext cx="7772400" cy="53496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82878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80975"/>
            <a:ext cx="10515600" cy="1325563"/>
          </a:xfrm>
        </p:spPr>
        <p:txBody>
          <a:bodyPr/>
          <a:lstStyle/>
          <a:p>
            <a:r>
              <a:rPr lang="en-US" dirty="0"/>
              <a:t>Drp1(-/17)-N2-22.08.05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A8CB1B8-9813-0256-5323-AD8CCC1C623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912112"/>
            <a:ext cx="7772400" cy="53993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35590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F02BB-4350-6652-BF52-93DC2DA4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302532"/>
            <a:ext cx="10515600" cy="1325563"/>
          </a:xfrm>
        </p:spPr>
        <p:txBody>
          <a:bodyPr/>
          <a:lstStyle/>
          <a:p>
            <a:r>
              <a:rPr lang="en-US" dirty="0"/>
              <a:t>Drp1(16/17)-N2-22.08.0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8EF4B57-A9F3-388B-3D3C-F69D44060B1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765061"/>
            <a:ext cx="7772400" cy="5327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21345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6F42E-BEDF-6988-1B0D-BF1648A30A8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kov3N3 2022.09.20 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82C3E0-B524-685F-72CB-3AE27D41311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10 days-  Normal media</a:t>
            </a:r>
          </a:p>
        </p:txBody>
      </p:sp>
    </p:spTree>
    <p:extLst>
      <p:ext uri="{BB962C8B-B14F-4D97-AF65-F5344CB8AC3E}">
        <p14:creationId xmlns:p14="http://schemas.microsoft.com/office/powerpoint/2010/main" val="3118553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8</TotalTime>
  <Words>48</Words>
  <Application>Microsoft Macintosh PowerPoint</Application>
  <PresentationFormat>Widescreen</PresentationFormat>
  <Paragraphs>15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Skov3N1 2022.08.05  </vt:lpstr>
      <vt:lpstr>GFP-N1 22.08.05</vt:lpstr>
      <vt:lpstr>Drp1(-/17)-N1-22.08.05</vt:lpstr>
      <vt:lpstr>Drp1(16/17)-N1-22.08.05</vt:lpstr>
      <vt:lpstr>Skov3N2 2022.08.05  </vt:lpstr>
      <vt:lpstr>GFP-N2 22.08.05</vt:lpstr>
      <vt:lpstr>Drp1(-/17)-N2-22.08.05</vt:lpstr>
      <vt:lpstr>Drp1(16/17)-N2-22.08.05</vt:lpstr>
      <vt:lpstr>Skov3N3 2022.09.20  </vt:lpstr>
      <vt:lpstr>GFP-N3 22.09.20</vt:lpstr>
      <vt:lpstr>Drp1(-/17)-N3-22.09.20</vt:lpstr>
      <vt:lpstr>Drp1(16/17)-N3-22.09.20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ved, Zaineb</dc:creator>
  <cp:lastModifiedBy>Zaineb Javed</cp:lastModifiedBy>
  <cp:revision>14</cp:revision>
  <dcterms:created xsi:type="dcterms:W3CDTF">2022-06-21T17:08:31Z</dcterms:created>
  <dcterms:modified xsi:type="dcterms:W3CDTF">2024-05-20T16:43:38Z</dcterms:modified>
</cp:coreProperties>
</file>